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0058400" cy="7772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44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642" y="-96"/>
      </p:cViewPr>
      <p:guideLst>
        <p:guide orient="horz" pos="2448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414482"/>
            <a:ext cx="8549640" cy="166602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4404360"/>
            <a:ext cx="704088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99187" y="456989"/>
            <a:ext cx="1922621" cy="972629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833" y="456989"/>
            <a:ext cx="5603716" cy="972629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4994487"/>
            <a:ext cx="8549640" cy="154368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294275"/>
            <a:ext cx="8549640" cy="17002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837" y="2659169"/>
            <a:ext cx="3763169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58640" y="2659169"/>
            <a:ext cx="3763170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739795"/>
            <a:ext cx="4444207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464859"/>
            <a:ext cx="4444207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34" y="1739795"/>
            <a:ext cx="4445953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34" y="2464859"/>
            <a:ext cx="4445953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09456"/>
            <a:ext cx="3309144" cy="13169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4" y="309457"/>
            <a:ext cx="5622926" cy="663352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0" y="1626447"/>
            <a:ext cx="3309144" cy="531653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5440680"/>
            <a:ext cx="6035040" cy="6423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694479"/>
            <a:ext cx="6035040" cy="4663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6082983"/>
            <a:ext cx="6035040" cy="91217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13565"/>
            <a:ext cx="9052560" cy="51294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7203865"/>
            <a:ext cx="31851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827698566"/>
              </p:ext>
            </p:extLst>
          </p:nvPr>
        </p:nvGraphicFramePr>
        <p:xfrm>
          <a:off x="1371600" y="942109"/>
          <a:ext cx="6324600" cy="3532905"/>
        </p:xfrm>
        <a:graphic>
          <a:graphicData uri="http://schemas.openxmlformats.org/drawingml/2006/table">
            <a:tbl>
              <a:tblPr/>
              <a:tblGrid>
                <a:gridCol w="1450477"/>
                <a:gridCol w="4874123"/>
              </a:tblGrid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utan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dult phenotype </a:t>
                      </a:r>
                      <a:r>
                        <a:rPr lang="en-US" sz="900" b="1" i="0" u="none" strike="noStrike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n </a:t>
                      </a:r>
                      <a:r>
                        <a:rPr lang="en-US" sz="900" b="1" i="1" u="none" strike="noStrike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yw</a:t>
                      </a:r>
                      <a:r>
                        <a:rPr lang="en-US" sz="900" b="1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b="1" i="1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yFLP</a:t>
                      </a:r>
                      <a:r>
                        <a:rPr lang="en-US" sz="900" b="1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; </a:t>
                      </a:r>
                      <a:r>
                        <a:rPr lang="en-US" sz="900" b="1" i="1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ubiGFP</a:t>
                      </a:r>
                      <a:r>
                        <a:rPr lang="en-US" sz="900" b="1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FRT40A/ </a:t>
                      </a:r>
                      <a:r>
                        <a:rPr lang="el-GR" sz="900" b="1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Δ</a:t>
                      </a:r>
                      <a:r>
                        <a:rPr lang="en-US" sz="900" b="1" i="1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isC</a:t>
                      </a:r>
                      <a:r>
                        <a:rPr lang="en-US" sz="900" b="1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FRT40A; 12xHisGU</a:t>
                      </a:r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WT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 (0/103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K56R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mall eyes, Slightly rough eyes (4/112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K56Q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lightly rough eyes (11/110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T80A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 (0/42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T80E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 (0/73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K115R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ery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lighly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rough eyes (1/110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K115Q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ery slightly rough eyes (10/111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T118A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 (0/97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T118E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 (0/133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T118I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 (0/113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K122R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lightly rough eyes (7/102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K122Q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 (0/100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K115R/K122R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o (0/118)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5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 K115Q/K122Q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mall eyes (3/3) Most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utants were </a:t>
                      </a:r>
                      <a:r>
                        <a:rPr lang="en-US" sz="9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upal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ethal or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closed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and died in food</a:t>
                      </a:r>
                    </a:p>
                  </a:txBody>
                  <a:tcPr marL="6141" marR="6141" marT="36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0" y="117764"/>
            <a:ext cx="956534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upplemental Figure 6</a:t>
            </a:r>
            <a:r>
              <a:rPr lang="en-US" sz="1000" b="1" dirty="0" smtClean="0">
                <a:latin typeface="Arial"/>
                <a:cs typeface="Arial"/>
              </a:rPr>
              <a:t>.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6056010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130</Words>
  <Application>Microsoft Office PowerPoint</Application>
  <PresentationFormat>Custom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illary Graves</dc:creator>
  <cp:lastModifiedBy>0002401</cp:lastModifiedBy>
  <cp:revision>28</cp:revision>
  <cp:lastPrinted>2015-11-20T14:49:24Z</cp:lastPrinted>
  <dcterms:created xsi:type="dcterms:W3CDTF">2015-10-29T21:52:50Z</dcterms:created>
  <dcterms:modified xsi:type="dcterms:W3CDTF">2016-02-22T11:48:35Z</dcterms:modified>
</cp:coreProperties>
</file>